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  <p:sldId id="257" r:id="rId3"/>
    <p:sldId id="258" r:id="rId4"/>
    <p:sldId id="259" r:id="rId5"/>
    <p:sldId id="260" r:id="rId6"/>
    <p:sldId id="262" r:id="rId7"/>
    <p:sldId id="261" r:id="rId8"/>
  </p:sldIdLst>
  <p:sldSz cx="6858000" cy="9144000" type="screen4x3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2" autoAdjust="0"/>
    <p:restoredTop sz="94660"/>
  </p:normalViewPr>
  <p:slideViewPr>
    <p:cSldViewPr snapToGrid="0">
      <p:cViewPr>
        <p:scale>
          <a:sx n="70" d="100"/>
          <a:sy n="70" d="100"/>
        </p:scale>
        <p:origin x="1608" y="-110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TW" altLang="en-US"/>
              <a:t>按一下以編輯母片副標題樣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5D3CCD-91DC-4FB0-9181-58026CAF7B45}" type="datetimeFigureOut">
              <a:rPr lang="zh-TW" altLang="en-US" smtClean="0"/>
              <a:t>2022/12/30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28B883-3DBE-4FE3-9D11-92838A92860C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9723577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5D3CCD-91DC-4FB0-9181-58026CAF7B45}" type="datetimeFigureOut">
              <a:rPr lang="zh-TW" altLang="en-US" smtClean="0"/>
              <a:t>2022/12/30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28B883-3DBE-4FE3-9D11-92838A92860C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7936360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5D3CCD-91DC-4FB0-9181-58026CAF7B45}" type="datetimeFigureOut">
              <a:rPr lang="zh-TW" altLang="en-US" smtClean="0"/>
              <a:t>2022/12/30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28B883-3DBE-4FE3-9D11-92838A92860C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4621606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5D3CCD-91DC-4FB0-9181-58026CAF7B45}" type="datetimeFigureOut">
              <a:rPr lang="zh-TW" altLang="en-US" smtClean="0"/>
              <a:t>2022/12/30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28B883-3DBE-4FE3-9D11-92838A92860C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7683835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5D3CCD-91DC-4FB0-9181-58026CAF7B45}" type="datetimeFigureOut">
              <a:rPr lang="zh-TW" altLang="en-US" smtClean="0"/>
              <a:t>2022/12/30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28B883-3DBE-4FE3-9D11-92838A92860C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2548418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5D3CCD-91DC-4FB0-9181-58026CAF7B45}" type="datetimeFigureOut">
              <a:rPr lang="zh-TW" altLang="en-US" smtClean="0"/>
              <a:t>2022/12/30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28B883-3DBE-4FE3-9D11-92838A92860C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5605853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5D3CCD-91DC-4FB0-9181-58026CAF7B45}" type="datetimeFigureOut">
              <a:rPr lang="zh-TW" altLang="en-US" smtClean="0"/>
              <a:t>2022/12/30</a:t>
            </a:fld>
            <a:endParaRPr lang="zh-TW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28B883-3DBE-4FE3-9D11-92838A92860C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6487023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5D3CCD-91DC-4FB0-9181-58026CAF7B45}" type="datetimeFigureOut">
              <a:rPr lang="zh-TW" altLang="en-US" smtClean="0"/>
              <a:t>2022/12/30</a:t>
            </a:fld>
            <a:endParaRPr lang="zh-TW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28B883-3DBE-4FE3-9D11-92838A92860C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9155401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5D3CCD-91DC-4FB0-9181-58026CAF7B45}" type="datetimeFigureOut">
              <a:rPr lang="zh-TW" altLang="en-US" smtClean="0"/>
              <a:t>2022/12/30</a:t>
            </a:fld>
            <a:endParaRPr lang="zh-TW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28B883-3DBE-4FE3-9D11-92838A92860C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541997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5D3CCD-91DC-4FB0-9181-58026CAF7B45}" type="datetimeFigureOut">
              <a:rPr lang="zh-TW" altLang="en-US" smtClean="0"/>
              <a:t>2022/12/30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28B883-3DBE-4FE3-9D11-92838A92860C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1967274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TW" altLang="en-US"/>
              <a:t>按一下圖示以新增圖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5D3CCD-91DC-4FB0-9181-58026CAF7B45}" type="datetimeFigureOut">
              <a:rPr lang="zh-TW" altLang="en-US" smtClean="0"/>
              <a:t>2022/12/30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28B883-3DBE-4FE3-9D11-92838A92860C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5082052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5D3CCD-91DC-4FB0-9181-58026CAF7B45}" type="datetimeFigureOut">
              <a:rPr lang="zh-TW" altLang="en-US" smtClean="0"/>
              <a:t>2022/12/30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28B883-3DBE-4FE3-9D11-92838A92860C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1562868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圖片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2301" y="2010077"/>
            <a:ext cx="6675699" cy="3334801"/>
          </a:xfrm>
          <a:prstGeom prst="rect">
            <a:avLst/>
          </a:prstGeom>
        </p:spPr>
      </p:pic>
      <p:sp>
        <p:nvSpPr>
          <p:cNvPr id="5" name="矩形 4"/>
          <p:cNvSpPr/>
          <p:nvPr/>
        </p:nvSpPr>
        <p:spPr>
          <a:xfrm>
            <a:off x="839857" y="5721770"/>
            <a:ext cx="5620578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TW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r>
              <a:rPr lang="en-US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Composition of microbial community (A) based on 16S rDNA amplicon sequencing, and (B) based on metagenomic sequencing</a:t>
            </a:r>
            <a:endParaRPr lang="zh-TW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4644693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圖片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9406" y="300528"/>
            <a:ext cx="6064522" cy="7151228"/>
          </a:xfrm>
          <a:prstGeom prst="rect">
            <a:avLst/>
          </a:prstGeom>
        </p:spPr>
      </p:pic>
      <p:sp>
        <p:nvSpPr>
          <p:cNvPr id="5" name="矩形 4"/>
          <p:cNvSpPr/>
          <p:nvPr/>
        </p:nvSpPr>
        <p:spPr>
          <a:xfrm>
            <a:off x="670020" y="7451756"/>
            <a:ext cx="5892245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TW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 </a:t>
            </a:r>
            <a:r>
              <a:rPr lang="en-US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ylogenetic analysis of ORFs predicted as </a:t>
            </a:r>
            <a:r>
              <a:rPr lang="en-US" altLang="zh-TW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moA</a:t>
            </a:r>
            <a:r>
              <a:rPr lang="en-US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amoA. This maximum-likelihood tree was reconstructed by using MEGA 7 (Kumar et al. 2016) with 1000 replications in the bootstrap test. The sequences retrieved from the studied reactor was labeled in blue.</a:t>
            </a:r>
            <a:endParaRPr lang="zh-TW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4518464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圖片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5400000">
            <a:off x="-170117" y="2847297"/>
            <a:ext cx="8573387" cy="3495019"/>
          </a:xfrm>
          <a:prstGeom prst="rect">
            <a:avLst/>
          </a:prstGeom>
        </p:spPr>
      </p:pic>
      <p:sp>
        <p:nvSpPr>
          <p:cNvPr id="5" name="矩形 4"/>
          <p:cNvSpPr/>
          <p:nvPr/>
        </p:nvSpPr>
        <p:spPr>
          <a:xfrm rot="5400000">
            <a:off x="-2505685" y="4151303"/>
            <a:ext cx="749615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TW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</a:t>
            </a:r>
            <a:r>
              <a:rPr lang="en-US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Metabolic versatilities of Nitrospira. The nodes with a bootstrap value higher than 90% are indicated as grey solid dots. The MAGs retrieved from the reactor of this study was labeled in blue.</a:t>
            </a:r>
            <a:endParaRPr lang="zh-TW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0594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圖片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9363" y="1343451"/>
            <a:ext cx="6608637" cy="4310246"/>
          </a:xfrm>
          <a:prstGeom prst="rect">
            <a:avLst/>
          </a:prstGeom>
        </p:spPr>
      </p:pic>
      <p:sp>
        <p:nvSpPr>
          <p:cNvPr id="5" name="矩形 4"/>
          <p:cNvSpPr/>
          <p:nvPr/>
        </p:nvSpPr>
        <p:spPr>
          <a:xfrm>
            <a:off x="425339" y="5422864"/>
            <a:ext cx="6256683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TW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. </a:t>
            </a:r>
            <a:r>
              <a:rPr lang="en-US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stribution of (A) modules of central carbon metabolism, and (B) marker genes for acetate metabolism.</a:t>
            </a:r>
            <a:endParaRPr lang="zh-TW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5480212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圖片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7706" y="1851180"/>
            <a:ext cx="6322100" cy="3414056"/>
          </a:xfrm>
          <a:prstGeom prst="rect">
            <a:avLst/>
          </a:prstGeom>
        </p:spPr>
      </p:pic>
      <p:sp>
        <p:nvSpPr>
          <p:cNvPr id="5" name="矩形 4"/>
          <p:cNvSpPr/>
          <p:nvPr/>
        </p:nvSpPr>
        <p:spPr>
          <a:xfrm>
            <a:off x="764906" y="5265236"/>
            <a:ext cx="540770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TW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5. </a:t>
            </a:r>
            <a:r>
              <a:rPr lang="en-US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stribution of modules of amino acid and vitamin biosynthesis.</a:t>
            </a:r>
            <a:endParaRPr lang="zh-TW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3151258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矩形 4"/>
          <p:cNvSpPr/>
          <p:nvPr/>
        </p:nvSpPr>
        <p:spPr>
          <a:xfrm>
            <a:off x="263386" y="7416411"/>
            <a:ext cx="6097657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TW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6. </a:t>
            </a:r>
            <a:r>
              <a:rPr lang="en-US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ylogenetic analysis of ORFs with inconsistent annotation results of class I and II ribonucleoside reductases using the KEGG classification system and </a:t>
            </a:r>
            <a:r>
              <a:rPr lang="en-US" altLang="zh-TW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lastp</a:t>
            </a:r>
            <a:r>
              <a:rPr lang="en-US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earch against nr database. This maximum-likelihood tree was reconstructed by using MEGA 7 (Kumar et al. 2016) with 1000 replications in the bootstrap test. The gene entity retrieved from the reactor of this study was labeled in blue.</a:t>
            </a:r>
            <a:r>
              <a:rPr lang="zh-TW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class III </a:t>
            </a:r>
            <a:r>
              <a:rPr lang="en-US" altLang="zh-TW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ibonucleoside</a:t>
            </a:r>
            <a:r>
              <a:rPr lang="en-US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ductases was used to root the tree.</a:t>
            </a:r>
            <a:endParaRPr lang="zh-TW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圖片 2" descr="一張含有 文字 的圖片&#10;&#10;自動產生的描述">
            <a:extLst>
              <a:ext uri="{FF2B5EF4-FFF2-40B4-BE49-F238E27FC236}">
                <a16:creationId xmlns:a16="http://schemas.microsoft.com/office/drawing/2014/main" xmlns="" id="{E374CC79-2208-1D87-318E-F51E6DFA1D0B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9261" b="15908"/>
          <a:stretch/>
        </p:blipFill>
        <p:spPr>
          <a:xfrm>
            <a:off x="263386" y="1338214"/>
            <a:ext cx="6330462" cy="59280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0298798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圖片 3"/>
          <p:cNvPicPr>
            <a:picLocks noChangeAspect="1"/>
          </p:cNvPicPr>
          <p:nvPr/>
        </p:nvPicPr>
        <p:blipFill rotWithShape="1">
          <a:blip r:embed="rId2"/>
          <a:srcRect b="3220"/>
          <a:stretch/>
        </p:blipFill>
        <p:spPr>
          <a:xfrm>
            <a:off x="109242" y="288325"/>
            <a:ext cx="6748758" cy="7381163"/>
          </a:xfrm>
          <a:prstGeom prst="rect">
            <a:avLst/>
          </a:prstGeom>
        </p:spPr>
      </p:pic>
      <p:sp>
        <p:nvSpPr>
          <p:cNvPr id="5" name="矩形 4"/>
          <p:cNvSpPr/>
          <p:nvPr/>
        </p:nvSpPr>
        <p:spPr>
          <a:xfrm>
            <a:off x="263386" y="7689366"/>
            <a:ext cx="6097657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TW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7. </a:t>
            </a:r>
            <a:r>
              <a:rPr lang="en-US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ylogenetic analysis of ORFs with inconsistent annotation results regarding the type of terminal oxidase using the KEGG classification system and </a:t>
            </a:r>
            <a:r>
              <a:rPr lang="en-US" altLang="zh-TW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lastp</a:t>
            </a:r>
            <a:r>
              <a:rPr lang="en-US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earch against </a:t>
            </a:r>
            <a:r>
              <a:rPr lang="en-US" altLang="zh-TW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r</a:t>
            </a:r>
            <a:r>
              <a:rPr lang="en-US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atabase. This maximum-likelihood tree was reconstructed by using MEGA 7 (Kumar et al. 2016) with 1000 replications in the bootstrap test. The gene entity retrieved from the reactor of this study was labeled in blue. </a:t>
            </a:r>
            <a:r>
              <a:rPr lang="en-US" altLang="zh-TW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. coli </a:t>
            </a:r>
            <a:r>
              <a:rPr lang="en-US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-12 bd-type terminal oxidase was used to root the tree.</a:t>
            </a:r>
            <a:endParaRPr lang="zh-TW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197788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 佈景主題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佈景主題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佈景主題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82</TotalTime>
  <Words>311</Words>
  <Application>Microsoft Office PowerPoint</Application>
  <PresentationFormat>如螢幕大小 (4:3)</PresentationFormat>
  <Paragraphs>7</Paragraphs>
  <Slides>7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5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7</vt:i4>
      </vt:variant>
    </vt:vector>
  </HeadingPairs>
  <TitlesOfParts>
    <vt:vector size="13" baseType="lpstr">
      <vt:lpstr>新細明體</vt:lpstr>
      <vt:lpstr>Arial</vt:lpstr>
      <vt:lpstr>Calibri</vt:lpstr>
      <vt:lpstr>Calibri Light</vt:lpstr>
      <vt:lpstr>Times New Roman</vt:lpstr>
      <vt:lpstr>Office 佈景主題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WUJH</dc:creator>
  <cp:lastModifiedBy>Microsoft 帳戶</cp:lastModifiedBy>
  <cp:revision>7</cp:revision>
  <dcterms:created xsi:type="dcterms:W3CDTF">2022-09-16T03:14:03Z</dcterms:created>
  <dcterms:modified xsi:type="dcterms:W3CDTF">2022-12-30T10:25:21Z</dcterms:modified>
</cp:coreProperties>
</file>